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594AD-2C91-4335-B4AC-163651B82A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D35F3-7BB6-476E-B7DB-D3AD2A0C5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2A40D-487A-4D21-A436-641CCA05EA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43135-73C6-4EF7-9D7D-8DC23AF7ED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ADC93-5497-4B67-AC9E-B194628940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15CDA-803A-4461-8D23-B1BFF7D745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77F9D-59F7-42CA-81D3-7A6BA7F70B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FAB32-E068-489C-958A-DE763CF8E4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BA7F3-5F07-4620-955D-C1300BA05C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9F118-31BD-4C77-9A10-542DC518C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BCB5A-C0DA-447A-9407-1C1789E8F9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1DE55-1BEA-4AAA-8B27-5D7955AC51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7CB6CB-B8D1-4EF5-8DFB-55D2A986C81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"/>
          <p:cNvGrpSpPr/>
          <p:nvPr/>
        </p:nvGrpSpPr>
        <p:grpSpPr>
          <a:xfrm>
            <a:off x="2025720" y="385560"/>
            <a:ext cx="2663640" cy="3195720"/>
            <a:chOff x="2025720" y="385560"/>
            <a:chExt cx="2663640" cy="3195720"/>
          </a:xfrm>
        </p:grpSpPr>
        <p:pic>
          <p:nvPicPr>
            <p:cNvPr id="42" name="Picture 2" descr="C:\Users\yck\Desktop\Sp1-CDDis-Revision\cancer cell- RIP3.jpg"/>
            <p:cNvPicPr/>
            <p:nvPr/>
          </p:nvPicPr>
          <p:blipFill>
            <a:blip r:embed="rId1"/>
            <a:stretch/>
          </p:blipFill>
          <p:spPr>
            <a:xfrm>
              <a:off x="2745720" y="2568240"/>
              <a:ext cx="1439640" cy="43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C:\Users\yck\Desktop\Sp1-CDDis-Revision\cancer cell-actin.jpg"/>
            <p:cNvPicPr/>
            <p:nvPr/>
          </p:nvPicPr>
          <p:blipFill>
            <a:blip r:embed="rId2"/>
            <a:stretch/>
          </p:blipFill>
          <p:spPr>
            <a:xfrm>
              <a:off x="2745720" y="3077280"/>
              <a:ext cx="1439640" cy="50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C:\Users\yck\Desktop\Sp1-CDDis-Revision\cancer cell- Sp1.jpg"/>
            <p:cNvPicPr/>
            <p:nvPr/>
          </p:nvPicPr>
          <p:blipFill>
            <a:blip r:embed="rId3"/>
            <a:stretch/>
          </p:blipFill>
          <p:spPr>
            <a:xfrm>
              <a:off x="2745720" y="1997640"/>
              <a:ext cx="1439640" cy="54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5" descr="C:\Users\yck\Desktop\Sp1-CDDis-Revision\cancer cell-UHRF1.jpg"/>
            <p:cNvPicPr/>
            <p:nvPr/>
          </p:nvPicPr>
          <p:blipFill>
            <a:blip r:embed="rId4"/>
            <a:stretch/>
          </p:blipFill>
          <p:spPr>
            <a:xfrm>
              <a:off x="2745720" y="1421640"/>
              <a:ext cx="1439640" cy="50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6"/>
            <p:cNvSpPr/>
            <p:nvPr/>
          </p:nvSpPr>
          <p:spPr>
            <a:xfrm>
              <a:off x="2205720" y="2645640"/>
              <a:ext cx="54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RI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7"/>
            <p:cNvSpPr/>
            <p:nvPr/>
          </p:nvSpPr>
          <p:spPr>
            <a:xfrm>
              <a:off x="2277720" y="2105280"/>
              <a:ext cx="54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Sp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2025720" y="3232440"/>
              <a:ext cx="72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9"/>
            <p:cNvSpPr/>
            <p:nvPr/>
          </p:nvSpPr>
          <p:spPr>
            <a:xfrm>
              <a:off x="2070720" y="1548720"/>
              <a:ext cx="81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UHRF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1"/>
            <p:cNvSpPr/>
            <p:nvPr/>
          </p:nvSpPr>
          <p:spPr>
            <a:xfrm rot="10800000">
              <a:off x="2745360" y="385560"/>
              <a:ext cx="362880" cy="103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T-2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4"/>
            <p:cNvSpPr/>
            <p:nvPr/>
          </p:nvSpPr>
          <p:spPr>
            <a:xfrm rot="10800000">
              <a:off x="3119040" y="385560"/>
              <a:ext cx="362880" cy="103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4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8"/>
            <p:cNvSpPr/>
            <p:nvPr/>
          </p:nvSpPr>
          <p:spPr>
            <a:xfrm rot="10800000">
              <a:off x="3469320" y="385560"/>
              <a:ext cx="362880" cy="103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T-11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9"/>
            <p:cNvSpPr/>
            <p:nvPr/>
          </p:nvSpPr>
          <p:spPr>
            <a:xfrm rot="10800000">
              <a:off x="3816360" y="385560"/>
              <a:ext cx="362880" cy="103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K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4"/>
            <p:cNvSpPr/>
            <p:nvPr/>
          </p:nvSpPr>
          <p:spPr>
            <a:xfrm>
              <a:off x="4197600" y="1169640"/>
              <a:ext cx="49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46"/>
            <p:cNvSpPr/>
            <p:nvPr/>
          </p:nvSpPr>
          <p:spPr>
            <a:xfrm>
              <a:off x="4185720" y="2656440"/>
              <a:ext cx="35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6"/>
            <p:cNvSpPr/>
            <p:nvPr/>
          </p:nvSpPr>
          <p:spPr>
            <a:xfrm>
              <a:off x="4185720" y="3232440"/>
              <a:ext cx="35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46"/>
            <p:cNvSpPr/>
            <p:nvPr/>
          </p:nvSpPr>
          <p:spPr>
            <a:xfrm>
              <a:off x="4122720" y="150444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46"/>
            <p:cNvSpPr/>
            <p:nvPr/>
          </p:nvSpPr>
          <p:spPr>
            <a:xfrm>
              <a:off x="4113720" y="214164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TextBox 19"/>
          <p:cNvSpPr/>
          <p:nvPr/>
        </p:nvSpPr>
        <p:spPr>
          <a:xfrm>
            <a:off x="414360" y="522360"/>
            <a:ext cx="98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矩形 21"/>
          <p:cNvSpPr/>
          <p:nvPr/>
        </p:nvSpPr>
        <p:spPr>
          <a:xfrm>
            <a:off x="157320" y="4003560"/>
            <a:ext cx="6421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9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stern blotting analysis of lysates from the indicated cancer cell lines to measure the protein levels of UHRF1, Sp1, RIP3 and β-actin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5:48Z</dcterms:modified>
  <cp:revision>428</cp:revision>
  <dc:subject/>
  <dc:title>幻灯片 1</dc:title>
</cp:coreProperties>
</file>